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officedocument.obfuscatedFont" Extension="odttf"/>
  <Default ContentType="application/vnd.openxmlformats-package.relationships+xml" Extension="rels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ms-office.chartcolorstyle+xml" PartName="/ppt/charts/colors1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drawingml.chart+xml" PartName="/ppt/charts/chart1.xml"/>
  <Override ContentType="application/vnd.openxmlformats-officedocument.presentationml.notesSlide+xml" PartName="/ppt/notesSlides/notesSlide1.xml"/>
  <Override ContentType="application/binary" PartName="/ppt/metadata"/>
  <Override ContentType="application/vnd.openxmlformats-officedocument.presentationml.notesMaster+xml" PartName="/ppt/notesMasters/notesMaster1.xml"/>
  <Override ContentType="application/vnd.ms-office.chartstyle+xml" PartName="/ppt/charts/style1.xml"/>
  <Override ContentType="application/vnd.openxmlformats-officedocument.presentationml.presProps+xml" PartName="/ppt/presProps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6" roundtripDataSignature="AMtx7miV7IeSeZJSYiwJVK9OxcLjmCiEJ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customschemas.google.com/relationships/presentationmetadata" Target="metadata"/></Relationships>
</file>

<file path=ppt/charts/_rels/chart1.xml.rels><?xml version="1.0" encoding="UTF-8" standalone="yes"?>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C:\Users\User\Downloads\QC%202024-2025-TEMP%20GRAP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42140758895204"/>
          <c:y val="7.7484047402005471E-2"/>
          <c:w val="0.88202230102031953"/>
          <c:h val="0.74963752252025928"/>
        </c:manualLayout>
      </c:layout>
      <c:lineChart>
        <c:grouping val="standard"/>
        <c:varyColors val="0"/>
        <c:ser>
          <c:idx val="0"/>
          <c:order val="0"/>
          <c:tx>
            <c:strRef>
              <c:f>temprepatures!$B$62</c:f>
              <c:strCache>
                <c:ptCount val="1"/>
                <c:pt idx="0">
                  <c:v>UC Room Temp</c:v>
                </c:pt>
              </c:strCache>
            </c:strRef>
          </c:tx>
          <c:spPr>
            <a:ln w="28575" cap="rnd" cmpd="sng" algn="ctr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temprepatures!$A$63:$A$72</c:f>
              <c:strCache>
                <c:ptCount val="10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4</c:v>
                </c:pt>
                <c:pt idx="4">
                  <c:v>D5</c:v>
                </c:pt>
                <c:pt idx="5">
                  <c:v>D6</c:v>
                </c:pt>
                <c:pt idx="6">
                  <c:v>D7</c:v>
                </c:pt>
                <c:pt idx="7">
                  <c:v>D8</c:v>
                </c:pt>
                <c:pt idx="8">
                  <c:v>D9</c:v>
                </c:pt>
                <c:pt idx="9">
                  <c:v>D10</c:v>
                </c:pt>
              </c:strCache>
            </c:strRef>
          </c:cat>
          <c:val>
            <c:numRef>
              <c:f>temprepatures!$B$63:$B$72</c:f>
              <c:numCache>
                <c:formatCode>0.0</c:formatCode>
                <c:ptCount val="10"/>
                <c:pt idx="0">
                  <c:v>22.1</c:v>
                </c:pt>
                <c:pt idx="1">
                  <c:v>22.2</c:v>
                </c:pt>
                <c:pt idx="2">
                  <c:v>22.3</c:v>
                </c:pt>
                <c:pt idx="3">
                  <c:v>22.6</c:v>
                </c:pt>
                <c:pt idx="4">
                  <c:v>22.8</c:v>
                </c:pt>
                <c:pt idx="5">
                  <c:v>22.9</c:v>
                </c:pt>
                <c:pt idx="6">
                  <c:v>23</c:v>
                </c:pt>
                <c:pt idx="7">
                  <c:v>23</c:v>
                </c:pt>
                <c:pt idx="8">
                  <c:v>23.5</c:v>
                </c:pt>
                <c:pt idx="9">
                  <c:v>2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25F-46E8-8BDD-BCCA46349DFA}"/>
            </c:ext>
          </c:extLst>
        </c:ser>
        <c:ser>
          <c:idx val="1"/>
          <c:order val="1"/>
          <c:tx>
            <c:strRef>
              <c:f>temprepatures!$C$62</c:f>
              <c:strCache>
                <c:ptCount val="1"/>
                <c:pt idx="0">
                  <c:v>UC Drop Temp</c:v>
                </c:pt>
              </c:strCache>
            </c:strRef>
          </c:tx>
          <c:spPr>
            <a:ln w="28575" cap="rnd" cmpd="sng" algn="ctr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temprepatures!$A$63:$A$72</c:f>
              <c:strCache>
                <c:ptCount val="10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4</c:v>
                </c:pt>
                <c:pt idx="4">
                  <c:v>D5</c:v>
                </c:pt>
                <c:pt idx="5">
                  <c:v>D6</c:v>
                </c:pt>
                <c:pt idx="6">
                  <c:v>D7</c:v>
                </c:pt>
                <c:pt idx="7">
                  <c:v>D8</c:v>
                </c:pt>
                <c:pt idx="8">
                  <c:v>D9</c:v>
                </c:pt>
                <c:pt idx="9">
                  <c:v>D10</c:v>
                </c:pt>
              </c:strCache>
            </c:strRef>
          </c:cat>
          <c:val>
            <c:numRef>
              <c:f>temprepatures!$C$63:$C$72</c:f>
              <c:numCache>
                <c:formatCode>0.0</c:formatCode>
                <c:ptCount val="10"/>
                <c:pt idx="0">
                  <c:v>19</c:v>
                </c:pt>
                <c:pt idx="1">
                  <c:v>19.100000000000001</c:v>
                </c:pt>
                <c:pt idx="2">
                  <c:v>19.3</c:v>
                </c:pt>
                <c:pt idx="3">
                  <c:v>19.5</c:v>
                </c:pt>
                <c:pt idx="4">
                  <c:v>19.600000000000001</c:v>
                </c:pt>
                <c:pt idx="5">
                  <c:v>19.7</c:v>
                </c:pt>
                <c:pt idx="6">
                  <c:v>19.8</c:v>
                </c:pt>
                <c:pt idx="7">
                  <c:v>20</c:v>
                </c:pt>
                <c:pt idx="8">
                  <c:v>20.100000000000001</c:v>
                </c:pt>
                <c:pt idx="9">
                  <c:v>20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25F-46E8-8BDD-BCCA46349D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9525" cap="flat" cmpd="sng" algn="ctr">
              <a:solidFill>
                <a:schemeClr val="dk1">
                  <a:lumMod val="35000"/>
                  <a:lumOff val="65000"/>
                  <a:alpha val="33000"/>
                </a:schemeClr>
              </a:solidFill>
              <a:round/>
            </a:ln>
            <a:effectLst/>
          </c:spPr>
        </c:dropLines>
        <c:smooth val="0"/>
        <c:axId val="1798771664"/>
        <c:axId val="1798750544"/>
      </c:lineChart>
      <c:catAx>
        <c:axId val="1798771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spc="20" baseline="0">
                <a:solidFill>
                  <a:schemeClr val="dk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8750544"/>
        <c:crosses val="autoZero"/>
        <c:auto val="1"/>
        <c:lblAlgn val="ctr"/>
        <c:lblOffset val="100"/>
        <c:noMultiLvlLbl val="0"/>
      </c:catAx>
      <c:valAx>
        <c:axId val="1798750544"/>
        <c:scaling>
          <c:orientation val="minMax"/>
          <c:min val="15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spc="20" baseline="0">
                <a:solidFill>
                  <a:schemeClr val="dk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8771664"/>
        <c:crosses val="autoZero"/>
        <c:crossBetween val="between"/>
      </c:valAx>
      <c:spPr>
        <a:gradFill>
          <a:gsLst>
            <a:gs pos="100000">
              <a:schemeClr val="lt1">
                <a:lumMod val="95000"/>
              </a:schemeClr>
            </a:gs>
            <a:gs pos="0">
              <a:schemeClr val="lt1"/>
            </a:gs>
          </a:gsLst>
          <a:lin ang="5400000" scaled="0"/>
        </a:gradFill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393444403886603"/>
          <c:y val="0.60727467179638106"/>
          <c:w val="0.30299490709356697"/>
          <c:h val="0.17431577889591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lt1"/>
    </a:solidFill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29845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29845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29845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29845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29845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29845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29845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29845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3810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07225" y="1468550"/>
            <a:ext cx="6769576" cy="278637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5" name="Google Shape;85;p1"/>
          <p:cNvGraphicFramePr/>
          <p:nvPr/>
        </p:nvGraphicFramePr>
        <p:xfrm>
          <a:off x="758414" y="1468550"/>
          <a:ext cx="4602480" cy="2786380"/>
        </p:xfrm>
        <a:graphic>
          <a:graphicData uri="http://schemas.openxmlformats.org/drawingml/2006/chart">
            <c:chart r:id="rId4"/>
          </a:graphicData>
        </a:graphic>
      </p:graphicFrame>
      <p:sp>
        <p:nvSpPr>
          <p:cNvPr id="86" name="Google Shape;86;p1"/>
          <p:cNvSpPr txBox="1"/>
          <p:nvPr/>
        </p:nvSpPr>
        <p:spPr>
          <a:xfrm rot="-5400000">
            <a:off x="-457201" y="2532973"/>
            <a:ext cx="1900518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emperature (</a:t>
            </a:r>
            <a:r>
              <a:rPr b="1" baseline="30000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0</a:t>
            </a: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)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" name="Google Shape;87;p1"/>
          <p:cNvSpPr txBox="1"/>
          <p:nvPr/>
        </p:nvSpPr>
        <p:spPr>
          <a:xfrm>
            <a:off x="2109395" y="4254928"/>
            <a:ext cx="1900518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highlight>
                  <a:srgbClr val="FFFF00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D</a:t>
            </a:r>
            <a:r>
              <a:rPr b="1" lang="en-US" sz="1200">
                <a:solidFill>
                  <a:schemeClr val="dk1"/>
                </a:solidFill>
                <a:highlight>
                  <a:srgbClr val="FFFF00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onors</a:t>
            </a:r>
            <a:endParaRPr b="0" i="0" sz="1400" u="none" cap="none" strike="noStrike">
              <a:solidFill>
                <a:srgbClr val="000000"/>
              </a:solidFill>
              <a:highlight>
                <a:srgbClr val="FFFF00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8" name="Google Shape;88;p1"/>
          <p:cNvSpPr txBox="1"/>
          <p:nvPr/>
        </p:nvSpPr>
        <p:spPr>
          <a:xfrm>
            <a:off x="8608261" y="4254929"/>
            <a:ext cx="1900500" cy="2769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lang="en-US" sz="1200">
                <a:solidFill>
                  <a:schemeClr val="dk1"/>
                </a:solidFill>
                <a:highlight>
                  <a:srgbClr val="FFFF00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Donors</a:t>
            </a:r>
            <a:endParaRPr b="0" i="0" sz="1400" u="none" cap="none" strike="noStrike">
              <a:solidFill>
                <a:srgbClr val="000000"/>
              </a:solidFill>
              <a:highlight>
                <a:srgbClr val="FFFF00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" name="Google Shape;89;p1"/>
          <p:cNvSpPr txBox="1"/>
          <p:nvPr/>
        </p:nvSpPr>
        <p:spPr>
          <a:xfrm rot="-5400000">
            <a:off x="5396753" y="2723239"/>
            <a:ext cx="1900518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emperature (</a:t>
            </a:r>
            <a:r>
              <a:rPr b="1" baseline="30000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0</a:t>
            </a: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)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61525" y="4926775"/>
            <a:ext cx="11955300" cy="11697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u="none" cap="none" strike="noStrike">
                <a:solidFill>
                  <a:srgbClr val="1F1F1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1: Presentation of temperature curves over time for room temperature and vitrification solution temperature for the 2 groups</a:t>
            </a:r>
            <a:endParaRPr b="0" i="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n-US" u="none" cap="none" strike="noStrik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 </a:t>
            </a:r>
            <a:r>
              <a:rPr b="1" i="0" lang="en-US" u="none" cap="none" strike="noStrik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UC group</a:t>
            </a:r>
            <a:r>
              <a:rPr b="0" i="0" lang="en-US" u="none" cap="none" strike="noStrik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Uncontrolled room conditions (UC Room Temp) and corresponding drop temperatures (UC Drop Temp) recorded from Donor 1 (D1) to Donor 10 (D10).</a:t>
            </a:r>
            <a:endParaRPr/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n-US" u="none" cap="none" strike="noStrik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b) </a:t>
            </a:r>
            <a:r>
              <a:rPr b="1" i="0" lang="en-US" u="none" cap="none" strike="noStrik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 group</a:t>
            </a:r>
            <a:r>
              <a:rPr b="0" i="0" lang="en-US" u="none" cap="none" strike="noStrik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Controlled room conditions (C Room Temp) and corresponding drop temperatures (C Drop Temp) recorded from Donor 11 (D11) to Donor 16 (D16).</a:t>
            </a:r>
            <a:endParaRPr/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t/>
            </a:r>
            <a:endParaRPr b="0" i="0" u="none" cap="none" strike="noStrike">
              <a:solidFill>
                <a:srgbClr val="1F1F1F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1" name="Google Shape;91;p1"/>
          <p:cNvSpPr txBox="1"/>
          <p:nvPr/>
        </p:nvSpPr>
        <p:spPr>
          <a:xfrm>
            <a:off x="519953" y="654424"/>
            <a:ext cx="573741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b="0" i="0" lang="en-US" sz="16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1"/>
          <p:cNvSpPr txBox="1"/>
          <p:nvPr/>
        </p:nvSpPr>
        <p:spPr>
          <a:xfrm>
            <a:off x="6485512" y="748234"/>
            <a:ext cx="573741" cy="33855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b="0" i="0" lang="en-US" sz="16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8-11T08:37:29Z</dcterms:created>
  <dc:creator>Georges Raad</dc:creator>
</cp:coreProperties>
</file>